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32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orient="horz" pos="5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9" d="100"/>
          <a:sy n="89" d="100"/>
        </p:scale>
        <p:origin x="394" y="77"/>
      </p:cViewPr>
      <p:guideLst>
        <p:guide orient="horz" pos="2232"/>
        <p:guide pos="3840"/>
        <p:guide orient="horz" pos="5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E73F16-5A28-40B7-9077-1A6CFAB93748}" type="datetimeFigureOut">
              <a:rPr lang="de-CH" smtClean="0"/>
              <a:t>25.11.2025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C700FF-ED09-4A38-81F8-2953A360B405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90322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C700FF-ED09-4A38-81F8-2953A360B405}" type="slidenum">
              <a:rPr lang="de-CH" smtClean="0"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85999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727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352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09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143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318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29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045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27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665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66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770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25CDB-537E-432D-B9A6-8762EE49410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220495-0673-4819-8BF4-0C5BB411C8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458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75" t="9924" r="20288" b="33976"/>
          <a:stretch/>
        </p:blipFill>
        <p:spPr>
          <a:xfrm>
            <a:off x="-114300" y="1439283"/>
            <a:ext cx="3991596" cy="36168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08" t="21515" r="28057" b="23144"/>
          <a:stretch/>
        </p:blipFill>
        <p:spPr>
          <a:xfrm>
            <a:off x="3926766" y="1465322"/>
            <a:ext cx="4109868" cy="353701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84" t="31969" r="28900" b="25671"/>
          <a:stretch/>
        </p:blipFill>
        <p:spPr>
          <a:xfrm>
            <a:off x="8126311" y="2089140"/>
            <a:ext cx="3951389" cy="2698760"/>
          </a:xfrm>
          <a:prstGeom prst="rect">
            <a:avLst/>
          </a:prstGeom>
        </p:spPr>
      </p:pic>
      <p:sp>
        <p:nvSpPr>
          <p:cNvPr id="5" name="TextBox 3"/>
          <p:cNvSpPr txBox="1"/>
          <p:nvPr/>
        </p:nvSpPr>
        <p:spPr>
          <a:xfrm>
            <a:off x="8781949" y="1720138"/>
            <a:ext cx="2779928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Colorimetry  measurement for </a:t>
            </a:r>
            <a:r>
              <a:rPr lang="en-US" dirty="0"/>
              <a:t>protein </a:t>
            </a:r>
            <a:r>
              <a:rPr lang="en-US" sz="1100" dirty="0"/>
              <a:t>ladder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875691" y="2832718"/>
            <a:ext cx="88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err="1"/>
              <a:t>Alox</a:t>
            </a:r>
            <a:r>
              <a:rPr lang="de-CH" dirty="0"/>
              <a:t> - 5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116937" y="3406277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de-CH" dirty="0"/>
              <a:t>-</a:t>
            </a:r>
            <a:r>
              <a:rPr lang="de-CH" dirty="0" err="1"/>
              <a:t>actin</a:t>
            </a:r>
            <a:endParaRPr lang="en-US" dirty="0"/>
          </a:p>
        </p:txBody>
      </p:sp>
      <p:sp>
        <p:nvSpPr>
          <p:cNvPr id="8" name="TextBox 3"/>
          <p:cNvSpPr txBox="1"/>
          <p:nvPr/>
        </p:nvSpPr>
        <p:spPr>
          <a:xfrm>
            <a:off x="2149098" y="1177673"/>
            <a:ext cx="3456395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Chemiluminescence measurements for Alox-5 and b-actin</a:t>
            </a:r>
          </a:p>
        </p:txBody>
      </p:sp>
    </p:spTree>
    <p:extLst>
      <p:ext uri="{BB962C8B-B14F-4D97-AF65-F5344CB8AC3E}">
        <p14:creationId xmlns:p14="http://schemas.microsoft.com/office/powerpoint/2010/main" val="1319624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Breitbild</PresentationFormat>
  <Paragraphs>5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-Präsentation</vt:lpstr>
    </vt:vector>
  </TitlesOfParts>
  <Company>Emp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pta, Govind</dc:creator>
  <cp:lastModifiedBy>Bürki, Tina</cp:lastModifiedBy>
  <cp:revision>11</cp:revision>
  <dcterms:created xsi:type="dcterms:W3CDTF">2024-11-14T12:24:25Z</dcterms:created>
  <dcterms:modified xsi:type="dcterms:W3CDTF">2025-11-25T07:55:54Z</dcterms:modified>
</cp:coreProperties>
</file>